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0" d="100"/>
          <a:sy n="80" d="100"/>
        </p:scale>
        <p:origin x="68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0037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21697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9769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45947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087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57940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6161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3355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9502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56909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2999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14187E-C7A2-4E82-906E-AE79A14A9F14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51237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3379" y="602361"/>
            <a:ext cx="4036543" cy="5550246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CC104417-68D5-46CE-B210-A33B0B05C536}"/>
              </a:ext>
            </a:extLst>
          </p:cNvPr>
          <p:cNvSpPr/>
          <p:nvPr/>
        </p:nvSpPr>
        <p:spPr>
          <a:xfrm>
            <a:off x="1601884" y="4982532"/>
            <a:ext cx="1003801" cy="338554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PKMYT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FD8E7C0A-6EE5-4CB7-BBD6-BF51C7FCD914}"/>
              </a:ext>
            </a:extLst>
          </p:cNvPr>
          <p:cNvSpPr/>
          <p:nvPr/>
        </p:nvSpPr>
        <p:spPr>
          <a:xfrm>
            <a:off x="2484366" y="4017554"/>
            <a:ext cx="162167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ctr"/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PDAC-CN1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847FA5A9-3FFD-4217-9BE7-B11976C95D80}"/>
              </a:ext>
            </a:extLst>
          </p:cNvPr>
          <p:cNvCxnSpPr>
            <a:cxnSpLocks/>
          </p:cNvCxnSpPr>
          <p:nvPr/>
        </p:nvCxnSpPr>
        <p:spPr>
          <a:xfrm flipV="1">
            <a:off x="2631546" y="4334346"/>
            <a:ext cx="1368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" name="矩形 5"/>
          <p:cNvSpPr/>
          <p:nvPr/>
        </p:nvSpPr>
        <p:spPr>
          <a:xfrm>
            <a:off x="1714094" y="4436546"/>
            <a:ext cx="891591" cy="307777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P-6306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直角三角形 6"/>
          <p:cNvSpPr/>
          <p:nvPr/>
        </p:nvSpPr>
        <p:spPr>
          <a:xfrm flipH="1">
            <a:off x="2772954" y="4512800"/>
            <a:ext cx="1426488" cy="225403"/>
          </a:xfrm>
          <a:prstGeom prst="rtTriangle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CC104417-68D5-46CE-B210-A33B0B05C536}"/>
              </a:ext>
            </a:extLst>
          </p:cNvPr>
          <p:cNvSpPr/>
          <p:nvPr/>
        </p:nvSpPr>
        <p:spPr>
          <a:xfrm>
            <a:off x="1430362" y="4698052"/>
            <a:ext cx="1175323" cy="338554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altLang="zh-CN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KMYT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箭头连接符 8"/>
          <p:cNvCxnSpPr/>
          <p:nvPr/>
        </p:nvCxnSpPr>
        <p:spPr>
          <a:xfrm flipV="1">
            <a:off x="2525251" y="4911769"/>
            <a:ext cx="1524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矩形 14">
            <a:extLst>
              <a:ext uri="{FF2B5EF4-FFF2-40B4-BE49-F238E27FC236}">
                <a16:creationId xmlns:a16="http://schemas.microsoft.com/office/drawing/2014/main" id="{CC104417-68D5-46CE-B210-A33B0B05C536}"/>
              </a:ext>
            </a:extLst>
          </p:cNvPr>
          <p:cNvSpPr/>
          <p:nvPr/>
        </p:nvSpPr>
        <p:spPr>
          <a:xfrm>
            <a:off x="941673" y="1601328"/>
            <a:ext cx="1003801" cy="338554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KMYT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组合 16"/>
          <p:cNvGrpSpPr/>
          <p:nvPr/>
        </p:nvGrpSpPr>
        <p:grpSpPr>
          <a:xfrm>
            <a:off x="4391063" y="4898106"/>
            <a:ext cx="609986" cy="276999"/>
            <a:chOff x="-5698802" y="6919617"/>
            <a:chExt cx="609986" cy="276999"/>
          </a:xfrm>
        </p:grpSpPr>
        <p:sp>
          <p:nvSpPr>
            <p:cNvPr id="18" name="矩形 17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直接连接符 18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0" name="组合 19"/>
          <p:cNvGrpSpPr/>
          <p:nvPr/>
        </p:nvGrpSpPr>
        <p:grpSpPr>
          <a:xfrm>
            <a:off x="4378779" y="4664978"/>
            <a:ext cx="609986" cy="276999"/>
            <a:chOff x="-5698802" y="6919617"/>
            <a:chExt cx="609986" cy="276999"/>
          </a:xfrm>
        </p:grpSpPr>
        <p:sp>
          <p:nvSpPr>
            <p:cNvPr id="21" name="矩形 20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直接连接符 21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3" name="矩形 22"/>
          <p:cNvSpPr/>
          <p:nvPr/>
        </p:nvSpPr>
        <p:spPr>
          <a:xfrm>
            <a:off x="2740653" y="4803477"/>
            <a:ext cx="1625841" cy="394993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86823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5287" y="438353"/>
            <a:ext cx="4037236" cy="5551200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FD8E7C0A-6EE5-4CB7-BBD6-BF51C7FCD914}"/>
              </a:ext>
            </a:extLst>
          </p:cNvPr>
          <p:cNvSpPr/>
          <p:nvPr/>
        </p:nvSpPr>
        <p:spPr>
          <a:xfrm>
            <a:off x="3030847" y="4104944"/>
            <a:ext cx="162167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ctr"/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PDAC-CN1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847FA5A9-3FFD-4217-9BE7-B11976C95D80}"/>
              </a:ext>
            </a:extLst>
          </p:cNvPr>
          <p:cNvCxnSpPr>
            <a:cxnSpLocks/>
          </p:cNvCxnSpPr>
          <p:nvPr/>
        </p:nvCxnSpPr>
        <p:spPr>
          <a:xfrm flipV="1">
            <a:off x="3178027" y="4421736"/>
            <a:ext cx="1368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" name="直角三角形 4"/>
          <p:cNvSpPr/>
          <p:nvPr/>
        </p:nvSpPr>
        <p:spPr>
          <a:xfrm flipH="1">
            <a:off x="3162205" y="4588108"/>
            <a:ext cx="1426488" cy="225403"/>
          </a:xfrm>
          <a:prstGeom prst="rtTriangle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组合 12"/>
          <p:cNvGrpSpPr/>
          <p:nvPr/>
        </p:nvGrpSpPr>
        <p:grpSpPr>
          <a:xfrm flipH="1">
            <a:off x="2181482" y="5014617"/>
            <a:ext cx="609986" cy="276999"/>
            <a:chOff x="-5698802" y="6919617"/>
            <a:chExt cx="609986" cy="276999"/>
          </a:xfrm>
        </p:grpSpPr>
        <p:sp>
          <p:nvSpPr>
            <p:cNvPr id="14" name="矩形 13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直接连接符 14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6" name="组合 15"/>
          <p:cNvGrpSpPr/>
          <p:nvPr/>
        </p:nvGrpSpPr>
        <p:grpSpPr>
          <a:xfrm flipH="1">
            <a:off x="2177623" y="4744323"/>
            <a:ext cx="609986" cy="276999"/>
            <a:chOff x="-5698802" y="6919617"/>
            <a:chExt cx="609986" cy="276999"/>
          </a:xfrm>
        </p:grpSpPr>
        <p:sp>
          <p:nvSpPr>
            <p:cNvPr id="17" name="矩形 16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直接连接符 17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9" name="矩形 18"/>
          <p:cNvSpPr/>
          <p:nvPr/>
        </p:nvSpPr>
        <p:spPr>
          <a:xfrm>
            <a:off x="1218069" y="582157"/>
            <a:ext cx="10054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2105980" y="4436546"/>
            <a:ext cx="891591" cy="307777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P-6306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矩形 20"/>
          <p:cNvSpPr/>
          <p:nvPr/>
        </p:nvSpPr>
        <p:spPr>
          <a:xfrm>
            <a:off x="2997571" y="4860885"/>
            <a:ext cx="1625841" cy="394993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83178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3472" y="951489"/>
            <a:ext cx="4037236" cy="5551200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FD8E7C0A-6EE5-4CB7-BBD6-BF51C7FCD914}"/>
              </a:ext>
            </a:extLst>
          </p:cNvPr>
          <p:cNvSpPr/>
          <p:nvPr/>
        </p:nvSpPr>
        <p:spPr>
          <a:xfrm>
            <a:off x="3093960" y="2759645"/>
            <a:ext cx="162167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ctr"/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PDAC-CN1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847FA5A9-3FFD-4217-9BE7-B11976C95D80}"/>
              </a:ext>
            </a:extLst>
          </p:cNvPr>
          <p:cNvCxnSpPr>
            <a:cxnSpLocks/>
          </p:cNvCxnSpPr>
          <p:nvPr/>
        </p:nvCxnSpPr>
        <p:spPr>
          <a:xfrm flipV="1">
            <a:off x="3241140" y="3076437"/>
            <a:ext cx="1368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" name="矩形 4"/>
          <p:cNvSpPr/>
          <p:nvPr/>
        </p:nvSpPr>
        <p:spPr>
          <a:xfrm>
            <a:off x="2323688" y="3178637"/>
            <a:ext cx="891591" cy="307777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P-6306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直角三角形 5"/>
          <p:cNvSpPr/>
          <p:nvPr/>
        </p:nvSpPr>
        <p:spPr>
          <a:xfrm flipH="1">
            <a:off x="3382548" y="3254891"/>
            <a:ext cx="1426488" cy="225403"/>
          </a:xfrm>
          <a:prstGeom prst="rtTriangle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组合 10"/>
          <p:cNvGrpSpPr/>
          <p:nvPr/>
        </p:nvGrpSpPr>
        <p:grpSpPr>
          <a:xfrm>
            <a:off x="5115257" y="3761428"/>
            <a:ext cx="609986" cy="276999"/>
            <a:chOff x="-5698802" y="6919617"/>
            <a:chExt cx="609986" cy="276999"/>
          </a:xfrm>
        </p:grpSpPr>
        <p:sp>
          <p:nvSpPr>
            <p:cNvPr id="12" name="矩形 11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直接连接符 12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4" name="组合 13"/>
          <p:cNvGrpSpPr/>
          <p:nvPr/>
        </p:nvGrpSpPr>
        <p:grpSpPr>
          <a:xfrm>
            <a:off x="5102973" y="3528466"/>
            <a:ext cx="609986" cy="276999"/>
            <a:chOff x="-5698802" y="6919617"/>
            <a:chExt cx="609986" cy="276999"/>
          </a:xfrm>
        </p:grpSpPr>
        <p:sp>
          <p:nvSpPr>
            <p:cNvPr id="15" name="矩形 14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直接连接符 15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7" name="矩形 16"/>
          <p:cNvSpPr/>
          <p:nvPr/>
        </p:nvSpPr>
        <p:spPr>
          <a:xfrm>
            <a:off x="1474548" y="582157"/>
            <a:ext cx="74892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LK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/>
          <p:cNvSpPr/>
          <p:nvPr/>
        </p:nvSpPr>
        <p:spPr>
          <a:xfrm>
            <a:off x="3280340" y="3563931"/>
            <a:ext cx="1625841" cy="394993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00570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3472" y="951489"/>
            <a:ext cx="4089600" cy="5623200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FD8E7C0A-6EE5-4CB7-BBD6-BF51C7FCD914}"/>
              </a:ext>
            </a:extLst>
          </p:cNvPr>
          <p:cNvSpPr/>
          <p:nvPr/>
        </p:nvSpPr>
        <p:spPr>
          <a:xfrm>
            <a:off x="3457437" y="4056743"/>
            <a:ext cx="162167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ctr"/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PDAC-CN1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847FA5A9-3FFD-4217-9BE7-B11976C95D80}"/>
              </a:ext>
            </a:extLst>
          </p:cNvPr>
          <p:cNvCxnSpPr>
            <a:cxnSpLocks/>
          </p:cNvCxnSpPr>
          <p:nvPr/>
        </p:nvCxnSpPr>
        <p:spPr>
          <a:xfrm flipV="1">
            <a:off x="3604617" y="4373535"/>
            <a:ext cx="1368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" name="矩形 4"/>
          <p:cNvSpPr/>
          <p:nvPr/>
        </p:nvSpPr>
        <p:spPr>
          <a:xfrm>
            <a:off x="2687165" y="4475735"/>
            <a:ext cx="891591" cy="307777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P-6306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直角三角形 5"/>
          <p:cNvSpPr/>
          <p:nvPr/>
        </p:nvSpPr>
        <p:spPr>
          <a:xfrm flipH="1">
            <a:off x="3746025" y="4551989"/>
            <a:ext cx="1426488" cy="225403"/>
          </a:xfrm>
          <a:prstGeom prst="rtTriangle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组合 9"/>
          <p:cNvGrpSpPr/>
          <p:nvPr/>
        </p:nvGrpSpPr>
        <p:grpSpPr>
          <a:xfrm>
            <a:off x="5339782" y="5114859"/>
            <a:ext cx="609986" cy="276999"/>
            <a:chOff x="-5698802" y="6919617"/>
            <a:chExt cx="609986" cy="276999"/>
          </a:xfrm>
        </p:grpSpPr>
        <p:sp>
          <p:nvSpPr>
            <p:cNvPr id="11" name="矩形 10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直接连接符 11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3" name="组合 12"/>
          <p:cNvGrpSpPr/>
          <p:nvPr/>
        </p:nvGrpSpPr>
        <p:grpSpPr>
          <a:xfrm>
            <a:off x="5339782" y="4777392"/>
            <a:ext cx="609986" cy="276999"/>
            <a:chOff x="-5698802" y="6919617"/>
            <a:chExt cx="609986" cy="276999"/>
          </a:xfrm>
        </p:grpSpPr>
        <p:sp>
          <p:nvSpPr>
            <p:cNvPr id="14" name="矩形 13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直接连接符 14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6" name="矩形 15"/>
          <p:cNvSpPr/>
          <p:nvPr/>
        </p:nvSpPr>
        <p:spPr>
          <a:xfrm>
            <a:off x="1423253" y="582157"/>
            <a:ext cx="8002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DK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3578756" y="4863654"/>
            <a:ext cx="1625841" cy="394993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38593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3472" y="1365817"/>
            <a:ext cx="3699807" cy="5087235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961587" y="582157"/>
            <a:ext cx="12618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pho-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DK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FD8E7C0A-6EE5-4CB7-BBD6-BF51C7FCD914}"/>
              </a:ext>
            </a:extLst>
          </p:cNvPr>
          <p:cNvSpPr/>
          <p:nvPr/>
        </p:nvSpPr>
        <p:spPr>
          <a:xfrm>
            <a:off x="2993744" y="4213497"/>
            <a:ext cx="162167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ctr"/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PDAC-CN1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847FA5A9-3FFD-4217-9BE7-B11976C95D80}"/>
              </a:ext>
            </a:extLst>
          </p:cNvPr>
          <p:cNvCxnSpPr>
            <a:cxnSpLocks/>
          </p:cNvCxnSpPr>
          <p:nvPr/>
        </p:nvCxnSpPr>
        <p:spPr>
          <a:xfrm flipV="1">
            <a:off x="3140924" y="4530289"/>
            <a:ext cx="1368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" name="矩形 5"/>
          <p:cNvSpPr/>
          <p:nvPr/>
        </p:nvSpPr>
        <p:spPr>
          <a:xfrm>
            <a:off x="2223472" y="4632489"/>
            <a:ext cx="891591" cy="307777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P-6306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直角三角形 6"/>
          <p:cNvSpPr/>
          <p:nvPr/>
        </p:nvSpPr>
        <p:spPr>
          <a:xfrm flipH="1">
            <a:off x="3282332" y="4708743"/>
            <a:ext cx="1426488" cy="225403"/>
          </a:xfrm>
          <a:prstGeom prst="rtTriangle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组合 10"/>
          <p:cNvGrpSpPr/>
          <p:nvPr/>
        </p:nvGrpSpPr>
        <p:grpSpPr>
          <a:xfrm>
            <a:off x="5011056" y="5271613"/>
            <a:ext cx="609986" cy="276999"/>
            <a:chOff x="-5698802" y="6919617"/>
            <a:chExt cx="609986" cy="276999"/>
          </a:xfrm>
        </p:grpSpPr>
        <p:sp>
          <p:nvSpPr>
            <p:cNvPr id="12" name="矩形 11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直接连接符 12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4" name="组合 13"/>
          <p:cNvGrpSpPr/>
          <p:nvPr/>
        </p:nvGrpSpPr>
        <p:grpSpPr>
          <a:xfrm>
            <a:off x="5011056" y="4934146"/>
            <a:ext cx="609986" cy="276999"/>
            <a:chOff x="-5698802" y="6919617"/>
            <a:chExt cx="609986" cy="276999"/>
          </a:xfrm>
        </p:grpSpPr>
        <p:sp>
          <p:nvSpPr>
            <p:cNvPr id="15" name="矩形 14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直接连接符 15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7" name="矩形 16"/>
          <p:cNvSpPr/>
          <p:nvPr/>
        </p:nvSpPr>
        <p:spPr>
          <a:xfrm>
            <a:off x="3140924" y="4974287"/>
            <a:ext cx="1625841" cy="394993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064590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3472" y="951489"/>
            <a:ext cx="4037236" cy="5551200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1230892" y="582157"/>
            <a:ext cx="99258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KD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FD8E7C0A-6EE5-4CB7-BBD6-BF51C7FCD914}"/>
              </a:ext>
            </a:extLst>
          </p:cNvPr>
          <p:cNvSpPr/>
          <p:nvPr/>
        </p:nvSpPr>
        <p:spPr>
          <a:xfrm>
            <a:off x="3457149" y="4449802"/>
            <a:ext cx="162167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ctr"/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PDAC-CN1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847FA5A9-3FFD-4217-9BE7-B11976C95D80}"/>
              </a:ext>
            </a:extLst>
          </p:cNvPr>
          <p:cNvCxnSpPr>
            <a:cxnSpLocks/>
          </p:cNvCxnSpPr>
          <p:nvPr/>
        </p:nvCxnSpPr>
        <p:spPr>
          <a:xfrm flipV="1">
            <a:off x="3604329" y="4766594"/>
            <a:ext cx="1368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" name="矩形 5"/>
          <p:cNvSpPr/>
          <p:nvPr/>
        </p:nvSpPr>
        <p:spPr>
          <a:xfrm>
            <a:off x="2686877" y="4868794"/>
            <a:ext cx="891591" cy="307777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P-6306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直角三角形 6"/>
          <p:cNvSpPr/>
          <p:nvPr/>
        </p:nvSpPr>
        <p:spPr>
          <a:xfrm flipH="1">
            <a:off x="3745737" y="4945048"/>
            <a:ext cx="1426488" cy="225403"/>
          </a:xfrm>
          <a:prstGeom prst="rtTriangle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组合 13"/>
          <p:cNvGrpSpPr/>
          <p:nvPr/>
        </p:nvGrpSpPr>
        <p:grpSpPr>
          <a:xfrm flipH="1">
            <a:off x="2587598" y="5661941"/>
            <a:ext cx="694945" cy="276999"/>
            <a:chOff x="-5698802" y="6919617"/>
            <a:chExt cx="694945" cy="276999"/>
          </a:xfrm>
        </p:grpSpPr>
        <p:sp>
          <p:nvSpPr>
            <p:cNvPr id="15" name="矩形 14"/>
            <p:cNvSpPr/>
            <p:nvPr/>
          </p:nvSpPr>
          <p:spPr>
            <a:xfrm>
              <a:off x="-5674233" y="6919617"/>
              <a:ext cx="67037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直接连接符 15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1" name="矩形 10"/>
          <p:cNvSpPr/>
          <p:nvPr/>
        </p:nvSpPr>
        <p:spPr>
          <a:xfrm>
            <a:off x="3604329" y="5228791"/>
            <a:ext cx="1625841" cy="394993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720577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3472" y="951489"/>
            <a:ext cx="4037236" cy="5551200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769228" y="582157"/>
            <a:ext cx="14542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pho-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KD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FD8E7C0A-6EE5-4CB7-BBD6-BF51C7FCD914}"/>
              </a:ext>
            </a:extLst>
          </p:cNvPr>
          <p:cNvSpPr/>
          <p:nvPr/>
        </p:nvSpPr>
        <p:spPr>
          <a:xfrm>
            <a:off x="3322388" y="3952842"/>
            <a:ext cx="162167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ctr"/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PDAC-CN1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847FA5A9-3FFD-4217-9BE7-B11976C95D80}"/>
              </a:ext>
            </a:extLst>
          </p:cNvPr>
          <p:cNvCxnSpPr>
            <a:cxnSpLocks/>
          </p:cNvCxnSpPr>
          <p:nvPr/>
        </p:nvCxnSpPr>
        <p:spPr>
          <a:xfrm flipV="1">
            <a:off x="3469568" y="4269634"/>
            <a:ext cx="1368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" name="矩形 5"/>
          <p:cNvSpPr/>
          <p:nvPr/>
        </p:nvSpPr>
        <p:spPr>
          <a:xfrm>
            <a:off x="2430797" y="4412206"/>
            <a:ext cx="891591" cy="307777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P-6306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直角三角形 6"/>
          <p:cNvSpPr/>
          <p:nvPr/>
        </p:nvSpPr>
        <p:spPr>
          <a:xfrm flipH="1">
            <a:off x="3480844" y="4322174"/>
            <a:ext cx="1426488" cy="225403"/>
          </a:xfrm>
          <a:prstGeom prst="rtTriangle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组合 10"/>
          <p:cNvGrpSpPr/>
          <p:nvPr/>
        </p:nvGrpSpPr>
        <p:grpSpPr>
          <a:xfrm>
            <a:off x="5229038" y="5140860"/>
            <a:ext cx="694945" cy="276999"/>
            <a:chOff x="-5698802" y="6919617"/>
            <a:chExt cx="694945" cy="276999"/>
          </a:xfrm>
        </p:grpSpPr>
        <p:sp>
          <p:nvSpPr>
            <p:cNvPr id="12" name="矩形 11"/>
            <p:cNvSpPr/>
            <p:nvPr/>
          </p:nvSpPr>
          <p:spPr>
            <a:xfrm>
              <a:off x="-5674233" y="6919617"/>
              <a:ext cx="67037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直接连接符 12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4" name="矩形 13"/>
          <p:cNvSpPr/>
          <p:nvPr/>
        </p:nvSpPr>
        <p:spPr>
          <a:xfrm>
            <a:off x="3348249" y="4795179"/>
            <a:ext cx="1625841" cy="394993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67277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47</Words>
  <Application>Microsoft Office PowerPoint</Application>
  <PresentationFormat>宽屏</PresentationFormat>
  <Paragraphs>35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1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思敏</dc:creator>
  <cp:lastModifiedBy>王 思敏</cp:lastModifiedBy>
  <cp:revision>16</cp:revision>
  <dcterms:created xsi:type="dcterms:W3CDTF">2024-02-08T02:44:39Z</dcterms:created>
  <dcterms:modified xsi:type="dcterms:W3CDTF">2024-02-12T00:40:47Z</dcterms:modified>
</cp:coreProperties>
</file>